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100" d="100"/>
          <a:sy n="100" d="100"/>
        </p:scale>
        <p:origin x="-516" y="6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2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1447800" y="1613356"/>
            <a:ext cx="7543800" cy="3376637"/>
            <a:chOff x="2209800" y="2724090"/>
            <a:chExt cx="7543800" cy="3376637"/>
          </a:xfrm>
        </p:grpSpPr>
        <p:pic>
          <p:nvPicPr>
            <p:cNvPr id="2" name="Picture 2" descr="H:\xca11\xca11tuchdwna.jpg"/>
            <p:cNvPicPr>
              <a:picLocks noChangeAspect="1" noChangeArrowheads="1"/>
            </p:cNvPicPr>
            <p:nvPr/>
          </p:nvPicPr>
          <p:blipFill>
            <a:blip r:embed="rId2"/>
            <a:srcRect l="5882" r="5229"/>
            <a:stretch>
              <a:fillRect/>
            </a:stretch>
          </p:blipFill>
          <p:spPr bwMode="auto">
            <a:xfrm>
              <a:off x="2209800" y="2743164"/>
              <a:ext cx="7391400" cy="3357563"/>
            </a:xfrm>
            <a:prstGeom prst="rect">
              <a:avLst/>
            </a:prstGeom>
            <a:ln w="38100" cap="sq">
              <a:solidFill>
                <a:srgbClr val="000000"/>
              </a:solidFill>
              <a:prstDash val="solid"/>
              <a:miter lim="800000"/>
            </a:ln>
            <a:effectLst>
              <a:outerShdw blurRad="50800" dist="38100" dir="2700000" algn="tl" rotWithShape="0">
                <a:srgbClr val="000000">
                  <a:alpha val="43000"/>
                </a:srgbClr>
              </a:outerShdw>
            </a:effectLst>
          </p:spPr>
        </p:pic>
        <p:sp>
          <p:nvSpPr>
            <p:cNvPr id="3" name="TextBox 2"/>
            <p:cNvSpPr txBox="1"/>
            <p:nvPr/>
          </p:nvSpPr>
          <p:spPr>
            <a:xfrm>
              <a:off x="2667000" y="2724090"/>
              <a:ext cx="70866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   M         1           2          3             4            5            6            7        8           9           10         11         12          13        14         15         16         17         18       19 </a:t>
              </a:r>
              <a:endParaRPr lang="en-US" sz="8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2743200" y="3701534"/>
              <a:ext cx="68865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   M        20          21      22          23        24         25         26          27        28         29        30         31         32        33         34          35         36         37         38</a:t>
              </a:r>
              <a:endParaRPr lang="en-US" sz="8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819400" y="5029200"/>
              <a:ext cx="5334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M             39              40             41              42            43            44             45             46                 47            48</a:t>
              </a:r>
              <a:endParaRPr lang="en-US" sz="8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6" name="TextBox 5"/>
          <p:cNvSpPr txBox="1"/>
          <p:nvPr/>
        </p:nvSpPr>
        <p:spPr>
          <a:xfrm>
            <a:off x="1371600" y="5105400"/>
            <a:ext cx="7543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S7.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Amplification of Genic-SSR marker Xcadas11 developed in the present study in 48 germplasm accessions of Senna. M: 100bp marker, 1-48: germplasm accessions.</a:t>
            </a:r>
            <a:endParaRPr lang="en-IN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7</TotalTime>
  <Words>83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UCHA</dc:creator>
  <cp:lastModifiedBy>Dell</cp:lastModifiedBy>
  <cp:revision>16</cp:revision>
  <dcterms:created xsi:type="dcterms:W3CDTF">2006-08-16T00:00:00Z</dcterms:created>
  <dcterms:modified xsi:type="dcterms:W3CDTF">2015-02-01T10:52:26Z</dcterms:modified>
</cp:coreProperties>
</file>